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5" autoAdjust="0"/>
    <p:restoredTop sz="94660"/>
  </p:normalViewPr>
  <p:slideViewPr>
    <p:cSldViewPr snapToGrid="0" showGuides="1">
      <p:cViewPr>
        <p:scale>
          <a:sx n="120" d="100"/>
          <a:sy n="120" d="100"/>
        </p:scale>
        <p:origin x="468" y="4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56AC1-E7B2-4136-B028-7035C3AEB614}" type="datetimeFigureOut">
              <a:rPr kumimoji="1" lang="ja-JP" altLang="en-US" smtClean="0"/>
              <a:t>2024/4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85613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56AC1-E7B2-4136-B028-7035C3AEB614}" type="datetimeFigureOut">
              <a:rPr kumimoji="1" lang="ja-JP" altLang="en-US" smtClean="0"/>
              <a:t>2024/4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99113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56AC1-E7B2-4136-B028-7035C3AEB614}" type="datetimeFigureOut">
              <a:rPr kumimoji="1" lang="ja-JP" altLang="en-US" smtClean="0"/>
              <a:t>2024/4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08571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56AC1-E7B2-4136-B028-7035C3AEB614}" type="datetimeFigureOut">
              <a:rPr kumimoji="1" lang="ja-JP" altLang="en-US" smtClean="0"/>
              <a:t>2024/4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90564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56AC1-E7B2-4136-B028-7035C3AEB614}" type="datetimeFigureOut">
              <a:rPr kumimoji="1" lang="ja-JP" altLang="en-US" smtClean="0"/>
              <a:t>2024/4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68940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56AC1-E7B2-4136-B028-7035C3AEB614}" type="datetimeFigureOut">
              <a:rPr kumimoji="1" lang="ja-JP" altLang="en-US" smtClean="0"/>
              <a:t>2024/4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57882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56AC1-E7B2-4136-B028-7035C3AEB614}" type="datetimeFigureOut">
              <a:rPr kumimoji="1" lang="ja-JP" altLang="en-US" smtClean="0"/>
              <a:t>2024/4/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53235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56AC1-E7B2-4136-B028-7035C3AEB614}" type="datetimeFigureOut">
              <a:rPr kumimoji="1" lang="ja-JP" altLang="en-US" smtClean="0"/>
              <a:t>2024/4/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14796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56AC1-E7B2-4136-B028-7035C3AEB614}" type="datetimeFigureOut">
              <a:rPr kumimoji="1" lang="ja-JP" altLang="en-US" smtClean="0"/>
              <a:t>2024/4/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87719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56AC1-E7B2-4136-B028-7035C3AEB614}" type="datetimeFigureOut">
              <a:rPr kumimoji="1" lang="ja-JP" altLang="en-US" smtClean="0"/>
              <a:t>2024/4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9156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56AC1-E7B2-4136-B028-7035C3AEB614}" type="datetimeFigureOut">
              <a:rPr kumimoji="1" lang="ja-JP" altLang="en-US" smtClean="0"/>
              <a:t>2024/4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86219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D56AC1-E7B2-4136-B028-7035C3AEB614}" type="datetimeFigureOut">
              <a:rPr kumimoji="1" lang="ja-JP" altLang="en-US" smtClean="0"/>
              <a:t>2024/4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1242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4E3630F-A96B-1564-D1A0-64027CE9F8C2}"/>
              </a:ext>
            </a:extLst>
          </p:cNvPr>
          <p:cNvSpPr txBox="1"/>
          <p:nvPr/>
        </p:nvSpPr>
        <p:spPr>
          <a:xfrm>
            <a:off x="0" y="-1212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l Figure 3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8AF07A5-81DD-F84B-117E-DF1E7849C9BB}"/>
              </a:ext>
            </a:extLst>
          </p:cNvPr>
          <p:cNvSpPr txBox="1"/>
          <p:nvPr/>
        </p:nvSpPr>
        <p:spPr>
          <a:xfrm>
            <a:off x="246201" y="6774525"/>
            <a:ext cx="654785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. Examples of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rraya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p. sampled for detecting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derived environmental DNAs.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rraya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aves collected in the experimental greenhouse or in the field were arbitrarily selected from the trees which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collected or these surrounding trees, but not trees clearly (visually) infested with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A) Leaves that have or are likely to have the history of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festation, (B) Healthy leaves in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free experimental greenhouse of Institute for Plant Protection, NARO, Tsukuba city, Ibaraki Prefecture, Japan (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kumimoji="1"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 not live in this area)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42AE53F6-D769-59C6-0477-7F8E149CA18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5138" y="3599170"/>
            <a:ext cx="3707723" cy="2780792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E7663605-8973-7439-4A01-4358EA17330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5138" y="762683"/>
            <a:ext cx="3707723" cy="2780792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7B8DF41-ADFD-228C-2299-B526E47462D0}"/>
              </a:ext>
            </a:extLst>
          </p:cNvPr>
          <p:cNvSpPr txBox="1"/>
          <p:nvPr/>
        </p:nvSpPr>
        <p:spPr>
          <a:xfrm>
            <a:off x="974960" y="754089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1468D18-98A7-E01A-3B61-9C3B1F29B86E}"/>
              </a:ext>
            </a:extLst>
          </p:cNvPr>
          <p:cNvSpPr txBox="1"/>
          <p:nvPr/>
        </p:nvSpPr>
        <p:spPr>
          <a:xfrm>
            <a:off x="923664" y="3896179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488748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40</TotalTime>
  <Words>125</Words>
  <Application>Microsoft Office PowerPoint</Application>
  <PresentationFormat>画面に合わせる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藤川貴史</dc:creator>
  <cp:lastModifiedBy>藤川貴史</cp:lastModifiedBy>
  <cp:revision>10</cp:revision>
  <dcterms:created xsi:type="dcterms:W3CDTF">2024-04-04T00:00:11Z</dcterms:created>
  <dcterms:modified xsi:type="dcterms:W3CDTF">2024-04-04T09:55:17Z</dcterms:modified>
</cp:coreProperties>
</file>